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871D6E-7AC0-45BC-8008-DA7D9A71538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EDF5E9-906C-4A9E-A169-54ECE1195C2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70509F-05CD-492F-9054-689A5F2DC71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C292AE-647E-4A61-B7AB-71E506941EF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39992D-9030-40AF-9C07-3E4D0C59B9E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B53B45-F7A5-4788-8A94-F66DDAE0B29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10A6D3-8C48-4E73-9B55-0C2CF7F8C69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66D82B-4CDA-4E74-B396-1E7DC205B48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56F752-592A-4125-A3AB-2EA8915277A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25963B-FDA2-4DA5-A4C0-E6E5A2FB46E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7664C2-4304-4DFD-BE51-98C62963F5C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3776E3-29A3-468C-BD36-5B390D67208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AAEE1A8-C4A7-4672-BFD4-A87CBE124301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825480" y="1425600"/>
          <a:ext cx="5207040" cy="2103480"/>
        </p:xfrm>
        <a:graphic>
          <a:graphicData uri="http://schemas.openxmlformats.org/drawingml/2006/table">
            <a:tbl>
              <a:tblPr/>
              <a:tblGrid>
                <a:gridCol w="2125800"/>
                <a:gridCol w="1533240"/>
                <a:gridCol w="1548000"/>
              </a:tblGrid>
              <a:tr h="433080">
                <a:tc>
                  <a:txBody>
                    <a:bodyPr anchor="ctr" anchorCtr="1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ctr" anchorCtr="1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 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robes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&gt; Background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ctr" anchorCtr="1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Unigenes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epresented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62440">
                <a:tc>
                  <a:txBody>
                    <a:bodyPr anchor="b">
                      <a:noAutofit/>
                    </a:bodyPr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apsicum spp.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,903,09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0,81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433080">
                <a:tc>
                  <a:txBody>
                    <a:bodyPr anchor="b">
                      <a:noAutofit/>
                    </a:bodyPr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. melongea 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v. Black Beauty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,345,50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0,80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62440">
                <a:tc>
                  <a:txBody>
                    <a:bodyPr anchor="b">
                      <a:noAutofit/>
                    </a:bodyPr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. pennellii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,268,39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0,78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62440">
                <a:tc>
                  <a:txBody>
                    <a:bodyPr anchor="b">
                      <a:noAutofit/>
                    </a:bodyPr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. lycopersicum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,385,28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0,79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62440">
                <a:tc>
                  <a:txBody>
                    <a:bodyPr anchor="b">
                      <a:noAutofit/>
                    </a:bodyPr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. tuberosum 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20-0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,701,11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0,80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62440">
                <a:tc>
                  <a:txBody>
                    <a:bodyPr anchor="b">
                      <a:noAutofit/>
                    </a:bodyPr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. tuberosum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10618-0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,681,82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0,79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2" name="TextBox 2"/>
          <p:cNvSpPr/>
          <p:nvPr/>
        </p:nvSpPr>
        <p:spPr>
          <a:xfrm>
            <a:off x="782640" y="3567240"/>
            <a:ext cx="520848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robes &gt; background = probes  hybridized at levels greater than the 90</a:t>
            </a:r>
            <a:r>
              <a:rPr b="0" lang="en-US" sz="12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th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percentile of antigenomic probes and Unigenes represented = the number of unigenes with probes hybridized above background levels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TextBox 4"/>
          <p:cNvSpPr/>
          <p:nvPr/>
        </p:nvSpPr>
        <p:spPr>
          <a:xfrm>
            <a:off x="782640" y="1133640"/>
            <a:ext cx="5208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able S4. Hybridization efficiency of </a:t>
            </a:r>
            <a:r>
              <a:rPr b="1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olunum spp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3-13T04:24:19Z</dcterms:created>
  <dc:creator>Theresa Hill</dc:creator>
  <dc:description/>
  <dc:language>en-US</dc:language>
  <cp:lastModifiedBy>Theresa Hill</cp:lastModifiedBy>
  <dcterms:modified xsi:type="dcterms:W3CDTF">2012-09-07T07:33:17Z</dcterms:modified>
  <cp:revision>3</cp:revision>
  <dc:subject/>
  <dc:title>PowerPoint Presentation</dc:title>
</cp:coreProperties>
</file>